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Main figures" id="{CADA7651-1228-4BE9-9DEC-580DF435650A}">
          <p14:sldIdLst>
            <p14:sldId id="282"/>
          </p14:sldIdLst>
        </p14:section>
      </p14:sectionLst>
    </p:ex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FFFF"/>
    <a:srgbClr val="66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780"/>
    <p:restoredTop sz="92284" autoAdjust="0"/>
  </p:normalViewPr>
  <p:slideViewPr>
    <p:cSldViewPr>
      <p:cViewPr varScale="1">
        <p:scale>
          <a:sx n="86" d="100"/>
          <a:sy n="86" d="100"/>
        </p:scale>
        <p:origin x="-41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C9D446-414C-4A58-8989-61AFDD6A970B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5614C3-C943-4A93-B375-69A27853CA8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6192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5614C3-C943-4A93-B375-69A27853CA82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6461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2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l="5075" t="15576" r="27476" b="16235"/>
          <a:stretch/>
        </p:blipFill>
        <p:spPr>
          <a:xfrm>
            <a:off x="4050734" y="343723"/>
            <a:ext cx="2487895" cy="325500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/>
          <a:srcRect l="5710" t="15330" r="36205" b="14273"/>
          <a:stretch/>
        </p:blipFill>
        <p:spPr>
          <a:xfrm>
            <a:off x="1707274" y="343724"/>
            <a:ext cx="2112868" cy="331387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5"/>
          <a:srcRect l="6344" t="15453" r="36364" b="15131"/>
          <a:stretch/>
        </p:blipFill>
        <p:spPr>
          <a:xfrm>
            <a:off x="1707273" y="3533564"/>
            <a:ext cx="2112869" cy="3312951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6"/>
          <a:srcRect l="5869" t="16189" r="26842" b="15499"/>
          <a:stretch/>
        </p:blipFill>
        <p:spPr>
          <a:xfrm>
            <a:off x="4057616" y="3587011"/>
            <a:ext cx="2481013" cy="3259504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76200" y="1542888"/>
            <a:ext cx="150791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tients with</a:t>
            </a:r>
          </a:p>
          <a:p>
            <a:r>
              <a:rPr lang="en-US" dirty="0"/>
              <a:t>positive T-cell </a:t>
            </a:r>
          </a:p>
          <a:p>
            <a:r>
              <a:rPr lang="en-US" dirty="0"/>
              <a:t>response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658476" y="5454029"/>
            <a:ext cx="4971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K2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658476" y="4778009"/>
            <a:ext cx="8638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YC </a:t>
            </a:r>
          </a:p>
          <a:p>
            <a:r>
              <a:rPr lang="en-US" sz="1200" dirty="0"/>
              <a:t>POU5F1B </a:t>
            </a:r>
          </a:p>
          <a:p>
            <a:r>
              <a:rPr lang="en-US" sz="1200" dirty="0"/>
              <a:t>PVT1 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 flipV="1">
            <a:off x="6411243" y="5094383"/>
            <a:ext cx="267609" cy="17902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6411243" y="5375281"/>
            <a:ext cx="359952" cy="129043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658476" y="1728984"/>
            <a:ext cx="7861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PTM4B</a:t>
            </a:r>
          </a:p>
          <a:p>
            <a:r>
              <a:rPr lang="en-US" sz="1200" dirty="0"/>
              <a:t>MTDH  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658476" y="2432928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DM5A </a:t>
            </a:r>
          </a:p>
        </p:txBody>
      </p:sp>
      <p:cxnSp>
        <p:nvCxnSpPr>
          <p:cNvPr id="22" name="Straight Arrow Connector 21"/>
          <p:cNvCxnSpPr/>
          <p:nvPr/>
        </p:nvCxnSpPr>
        <p:spPr>
          <a:xfrm flipV="1">
            <a:off x="6427564" y="1959817"/>
            <a:ext cx="230912" cy="104804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6519252" y="2571428"/>
            <a:ext cx="179976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369389" y="87868"/>
            <a:ext cx="983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eletio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495800" y="76200"/>
            <a:ext cx="1431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mplification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23601" y="4715470"/>
            <a:ext cx="172899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Patients without</a:t>
            </a:r>
            <a:endParaRPr lang="en-US" dirty="0"/>
          </a:p>
          <a:p>
            <a:r>
              <a:rPr lang="en-US" dirty="0"/>
              <a:t>positive T-cell </a:t>
            </a:r>
          </a:p>
          <a:p>
            <a:r>
              <a:rPr lang="en-US" dirty="0"/>
              <a:t>response</a:t>
            </a:r>
          </a:p>
        </p:txBody>
      </p:sp>
    </p:spTree>
    <p:extLst>
      <p:ext uri="{BB962C8B-B14F-4D97-AF65-F5344CB8AC3E}">
        <p14:creationId xmlns:p14="http://schemas.microsoft.com/office/powerpoint/2010/main" val="1761337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C000">
            <a:alpha val="50000"/>
          </a:srgbClr>
        </a:solidFill>
        <a:ln w="12700">
          <a:solidFill>
            <a:schemeClr val="tx2"/>
          </a:solidFill>
        </a:ln>
      </a:spPr>
      <a:bodyPr rtlCol="0" anchor="ctr"/>
      <a:lstStyle>
        <a:defPPr algn="ctr">
          <a:defRPr>
            <a:solidFill>
              <a:schemeClr val="accent6">
                <a:lumMod val="75000"/>
              </a:schemeClr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1</TotalTime>
  <Words>22</Words>
  <Application>Microsoft Office PowerPoint</Application>
  <PresentationFormat>On-screen Show (4:3)</PresentationFormat>
  <Paragraphs>1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rk</dc:creator>
  <cp:lastModifiedBy>Amit Lugade</cp:lastModifiedBy>
  <cp:revision>90</cp:revision>
  <dcterms:created xsi:type="dcterms:W3CDTF">2006-08-16T00:00:00Z</dcterms:created>
  <dcterms:modified xsi:type="dcterms:W3CDTF">2019-05-21T20:52:14Z</dcterms:modified>
</cp:coreProperties>
</file>